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  <p:sldId id="258" r:id="rId4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79" d="100"/>
          <a:sy n="79" d="100"/>
        </p:scale>
        <p:origin x="821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C3B5690-0815-6C48-24BA-F5E2CE2E4F8E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D58F4E1B-C605-0441-CE26-778F2378DF45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4DF571A-D7DE-B0FB-50F9-F3954CAD4AE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4AE392-4084-42CD-8780-9ABEBEC92076}" type="datetimeFigureOut">
              <a:rPr lang="en-GB" smtClean="0"/>
              <a:t>12/08/2024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71F72B3-B824-8B86-1034-B9887EBC079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31F0609-68C4-5B0E-6CB6-207809E5115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33B30A-8C37-4C3D-885D-C6BF8C17E23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7217971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D27D993-36B6-0B68-34C6-FA7AF397BF7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8BC57E7B-3539-35C6-1766-F0505B90021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A11F456-4948-DFA7-85D4-F836A33BCAF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4AE392-4084-42CD-8780-9ABEBEC92076}" type="datetimeFigureOut">
              <a:rPr lang="en-GB" smtClean="0"/>
              <a:t>12/08/2024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B8757D0-F16F-A01D-0C30-D873E1578E3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324F6FE-29B6-569B-3F11-0985FD425DE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33B30A-8C37-4C3D-885D-C6BF8C17E23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52322188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A29158A0-E3DA-FB5F-3EEE-1457F83661CF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179E5F05-1487-3308-7ACB-A2C656EDF75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65FFD22-4202-22CA-4622-C56ECC37040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4AE392-4084-42CD-8780-9ABEBEC92076}" type="datetimeFigureOut">
              <a:rPr lang="en-GB" smtClean="0"/>
              <a:t>12/08/2024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0FAAA7B-2675-BD1A-45CA-25C717C775B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D556339-BD73-1802-61DA-AC177F038C9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33B30A-8C37-4C3D-885D-C6BF8C17E23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1514116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73B39A4-419B-B745-6542-D1DCF7C7AE1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B1BC432-E0DE-60EB-388A-7B60157EC69B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073210A-74B5-FE8B-9BD2-83F76186BB9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4AE392-4084-42CD-8780-9ABEBEC92076}" type="datetimeFigureOut">
              <a:rPr lang="en-GB" smtClean="0"/>
              <a:t>12/08/2024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C52BF42-59E6-C06A-3366-1EE9880C721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6C40986-2E85-8CA8-482F-0062C4BA023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33B30A-8C37-4C3D-885D-C6BF8C17E23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3281107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77BB7F2-35CE-D6FB-D39A-C3D7FE44052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8EA0DA07-4586-FB4A-E5B4-369ED78E059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139858F-EF74-0C7C-4D9D-F8F3BD31609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4AE392-4084-42CD-8780-9ABEBEC92076}" type="datetimeFigureOut">
              <a:rPr lang="en-GB" smtClean="0"/>
              <a:t>12/08/2024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BC374EA-E066-55DB-6A1C-78A7C74AAAB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565F9A8-0A15-8600-336E-C723BAFF293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33B30A-8C37-4C3D-885D-C6BF8C17E23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2723897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B32A8E7-8EF7-67B8-2C9C-646B6827394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D66CB7E4-9848-5705-E086-679A5CD1DEAD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596EE812-844E-AEE1-4499-F951798DECA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B0C010BF-037F-B568-73A5-D1A46CC8A65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4AE392-4084-42CD-8780-9ABEBEC92076}" type="datetimeFigureOut">
              <a:rPr lang="en-GB" smtClean="0"/>
              <a:t>12/08/2024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1E703755-1C5C-AFDE-6C13-A7652A39CD4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0AAF068F-ECB5-1A6F-796E-994839424DC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33B30A-8C37-4C3D-885D-C6BF8C17E23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97842180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04AB0BD-8FD6-CEE8-A6E9-514974C8761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0D44D0BE-E863-6D63-61ED-2912FD8556D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B67B4D1D-1D88-93D0-FB9A-F5D578561F3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214FF188-B8D5-559C-E74D-BD7DEB902820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AAA6D4E7-6B7C-6D9E-4154-5A1D8886D820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D1FA14E8-538F-3158-8A29-FEAF04CF224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4AE392-4084-42CD-8780-9ABEBEC92076}" type="datetimeFigureOut">
              <a:rPr lang="en-GB" smtClean="0"/>
              <a:t>12/08/2024</a:t>
            </a:fld>
            <a:endParaRPr lang="en-GB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BFB98519-6A45-85FA-4B01-B78F55467F6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EF7628E3-8F9A-CB5A-F281-2E58A32BFE9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33B30A-8C37-4C3D-885D-C6BF8C17E23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7319368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3E2D96E-C128-ED78-4DA2-B73358ADB37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83629D7F-597B-2425-F28D-69921D08BF8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4AE392-4084-42CD-8780-9ABEBEC92076}" type="datetimeFigureOut">
              <a:rPr lang="en-GB" smtClean="0"/>
              <a:t>12/08/2024</a:t>
            </a:fld>
            <a:endParaRPr lang="en-GB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3C03DFDA-D010-613B-A443-8473EE07148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305CACFE-69AA-27E4-1243-44DC34AA60E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33B30A-8C37-4C3D-885D-C6BF8C17E23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8454886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53080DAB-20AA-B1B4-B824-CFC739C4B70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4AE392-4084-42CD-8780-9ABEBEC92076}" type="datetimeFigureOut">
              <a:rPr lang="en-GB" smtClean="0"/>
              <a:t>12/08/2024</a:t>
            </a:fld>
            <a:endParaRPr lang="en-GB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DF55C3B6-ABDF-4E7B-3D22-7574502F535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869EE14D-4D31-E3E0-2453-9F8B2F965F2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33B30A-8C37-4C3D-885D-C6BF8C17E23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0006575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4C612BE-3083-43FE-BF30-CB910A48207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442FE63-047A-2095-72BD-299801F76F97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E4446FA6-2FC3-410E-7C90-D7C833B4A8C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522D2223-ACF2-63CA-99F2-6D7860089FC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4AE392-4084-42CD-8780-9ABEBEC92076}" type="datetimeFigureOut">
              <a:rPr lang="en-GB" smtClean="0"/>
              <a:t>12/08/2024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97BCAF9A-14F8-0085-3EF7-9686347BE1C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271F3524-8A3C-C435-9E16-A1380A620E6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33B30A-8C37-4C3D-885D-C6BF8C17E23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9827481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6A59213-9764-BE65-0A7B-CCF2A69B28E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8503012B-C205-602D-BA90-2325CE4FE2EC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39AE9969-DF61-FAC5-9EFC-339902DB995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2584E3E3-2A7F-120E-32F4-EB0FE180DEE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4AE392-4084-42CD-8780-9ABEBEC92076}" type="datetimeFigureOut">
              <a:rPr lang="en-GB" smtClean="0"/>
              <a:t>12/08/2024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E5152EA9-17BA-36C1-0B10-A5B4B5DD584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786B0743-B782-394A-0CDE-A6BB22F05DA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33B30A-8C37-4C3D-885D-C6BF8C17E23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46843803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2E707DE9-E1FE-C7D9-A6CB-C3FC97C48B8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A6E3DC79-D383-11C5-138D-8E4CA4B73DC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98AACFB-56DF-1DBF-49CF-8BEFDEFA22D0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C54AE392-4084-42CD-8780-9ABEBEC92076}" type="datetimeFigureOut">
              <a:rPr lang="en-GB" smtClean="0"/>
              <a:t>12/08/2024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BC6DFA2-C13E-4097-136A-1730496CDA4C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C313E2F-3555-15B2-FBAD-EEF5BE56236E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A433B30A-8C37-4C3D-885D-C6BF8C17E23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4866666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"/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tif"/><Relationship Id="rId2" Type="http://schemas.openxmlformats.org/officeDocument/2006/relationships/image" Target="../media/image3.tif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tif"/><Relationship Id="rId2" Type="http://schemas.openxmlformats.org/officeDocument/2006/relationships/image" Target="../media/image5.ti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B6FB5D06-9D8E-D865-72D5-CF078A03E36D}"/>
              </a:ext>
            </a:extLst>
          </p:cNvPr>
          <p:cNvSpPr txBox="1"/>
          <p:nvPr/>
        </p:nvSpPr>
        <p:spPr>
          <a:xfrm>
            <a:off x="0" y="107004"/>
            <a:ext cx="225484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dirty="0">
                <a:latin typeface="Calibri" panose="020F0502020204030204" pitchFamily="34" charset="0"/>
                <a:cs typeface="Calibri" panose="020F0502020204030204" pitchFamily="34" charset="0"/>
              </a:rPr>
              <a:t>HT29_biological replicate n1</a:t>
            </a:r>
          </a:p>
        </p:txBody>
      </p:sp>
      <p:pic>
        <p:nvPicPr>
          <p:cNvPr id="6" name="Picture 5" descr="A close-up of a dna test&#10;&#10;Description automatically generated">
            <a:extLst>
              <a:ext uri="{FF2B5EF4-FFF2-40B4-BE49-F238E27FC236}">
                <a16:creationId xmlns:a16="http://schemas.microsoft.com/office/drawing/2014/main" id="{208F05F7-2460-501E-C33E-2E425D0C1B30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96645" y="754843"/>
            <a:ext cx="5799355" cy="3620239"/>
          </a:xfrm>
          <a:prstGeom prst="rect">
            <a:avLst/>
          </a:prstGeom>
        </p:spPr>
      </p:pic>
      <p:pic>
        <p:nvPicPr>
          <p:cNvPr id="8" name="Picture 7" descr="A close-up of a dna test&#10;&#10;Description automatically generated">
            <a:extLst>
              <a:ext uri="{FF2B5EF4-FFF2-40B4-BE49-F238E27FC236}">
                <a16:creationId xmlns:a16="http://schemas.microsoft.com/office/drawing/2014/main" id="{E06E0EE0-03EA-5136-97B8-A72D601836F2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307036" y="754843"/>
            <a:ext cx="5799355" cy="3620239"/>
          </a:xfrm>
          <a:prstGeom prst="rect">
            <a:avLst/>
          </a:prstGeom>
        </p:spPr>
      </p:pic>
      <p:sp>
        <p:nvSpPr>
          <p:cNvPr id="9" name="Rectangle 8">
            <a:extLst>
              <a:ext uri="{FF2B5EF4-FFF2-40B4-BE49-F238E27FC236}">
                <a16:creationId xmlns:a16="http://schemas.microsoft.com/office/drawing/2014/main" id="{711A7E84-E366-38AE-DDD7-D0561C9C8E5D}"/>
              </a:ext>
            </a:extLst>
          </p:cNvPr>
          <p:cNvSpPr/>
          <p:nvPr/>
        </p:nvSpPr>
        <p:spPr>
          <a:xfrm>
            <a:off x="1001966" y="2257185"/>
            <a:ext cx="1848678" cy="307777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6D4062C3-4A4C-6E0B-4B00-2EA39B91B531}"/>
              </a:ext>
            </a:extLst>
          </p:cNvPr>
          <p:cNvSpPr txBox="1"/>
          <p:nvPr/>
        </p:nvSpPr>
        <p:spPr>
          <a:xfrm>
            <a:off x="472426" y="2231683"/>
            <a:ext cx="50045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600" dirty="0">
                <a:solidFill>
                  <a:srgbClr val="FF000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p62</a:t>
            </a:r>
          </a:p>
        </p:txBody>
      </p:sp>
      <p:sp>
        <p:nvSpPr>
          <p:cNvPr id="11" name="Rectangle 10">
            <a:extLst>
              <a:ext uri="{FF2B5EF4-FFF2-40B4-BE49-F238E27FC236}">
                <a16:creationId xmlns:a16="http://schemas.microsoft.com/office/drawing/2014/main" id="{E49A64DE-9F8D-3472-E1B5-DC50FAACB7CB}"/>
              </a:ext>
            </a:extLst>
          </p:cNvPr>
          <p:cNvSpPr/>
          <p:nvPr/>
        </p:nvSpPr>
        <p:spPr>
          <a:xfrm>
            <a:off x="6988635" y="2489098"/>
            <a:ext cx="1848678" cy="307777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44CAB7E4-A407-749F-8EA4-6C4D9914054C}"/>
              </a:ext>
            </a:extLst>
          </p:cNvPr>
          <p:cNvSpPr txBox="1"/>
          <p:nvPr/>
        </p:nvSpPr>
        <p:spPr>
          <a:xfrm>
            <a:off x="6266160" y="2473709"/>
            <a:ext cx="763351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sz="1600" dirty="0">
                <a:solidFill>
                  <a:srgbClr val="FF000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β</a:t>
            </a:r>
            <a:r>
              <a:rPr lang="en-GB" sz="1600" dirty="0">
                <a:solidFill>
                  <a:srgbClr val="FF000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-actin</a:t>
            </a:r>
          </a:p>
        </p:txBody>
      </p:sp>
    </p:spTree>
    <p:extLst>
      <p:ext uri="{BB962C8B-B14F-4D97-AF65-F5344CB8AC3E}">
        <p14:creationId xmlns:p14="http://schemas.microsoft.com/office/powerpoint/2010/main" val="323224054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0F5550D2-5CD7-2C8D-4725-B366DFBE315B}"/>
              </a:ext>
            </a:extLst>
          </p:cNvPr>
          <p:cNvSpPr txBox="1"/>
          <p:nvPr/>
        </p:nvSpPr>
        <p:spPr>
          <a:xfrm>
            <a:off x="0" y="107004"/>
            <a:ext cx="225484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dirty="0">
                <a:latin typeface="Calibri" panose="020F0502020204030204" pitchFamily="34" charset="0"/>
                <a:cs typeface="Calibri" panose="020F0502020204030204" pitchFamily="34" charset="0"/>
              </a:rPr>
              <a:t>HT29_biological replicate n2</a:t>
            </a:r>
          </a:p>
        </p:txBody>
      </p:sp>
      <p:pic>
        <p:nvPicPr>
          <p:cNvPr id="6" name="Picture 5" descr="A close-up of a white background&#10;&#10;Description automatically generated">
            <a:extLst>
              <a:ext uri="{FF2B5EF4-FFF2-40B4-BE49-F238E27FC236}">
                <a16:creationId xmlns:a16="http://schemas.microsoft.com/office/drawing/2014/main" id="{9B73D3F0-E570-2124-1880-B1C52360C99F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41931" y="790416"/>
            <a:ext cx="5656426" cy="3536683"/>
          </a:xfrm>
          <a:prstGeom prst="rect">
            <a:avLst/>
          </a:prstGeom>
        </p:spPr>
      </p:pic>
      <p:pic>
        <p:nvPicPr>
          <p:cNvPr id="8" name="Picture 7" descr="A close-up of a test&#10;&#10;Description automatically generated">
            <a:extLst>
              <a:ext uri="{FF2B5EF4-FFF2-40B4-BE49-F238E27FC236}">
                <a16:creationId xmlns:a16="http://schemas.microsoft.com/office/drawing/2014/main" id="{ABA177F5-046C-4D0B-D426-C6D42D3A1BC8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966261" y="789501"/>
            <a:ext cx="5473678" cy="3537597"/>
          </a:xfrm>
          <a:prstGeom prst="rect">
            <a:avLst/>
          </a:prstGeom>
        </p:spPr>
      </p:pic>
      <p:sp>
        <p:nvSpPr>
          <p:cNvPr id="9" name="Rectangle 8">
            <a:extLst>
              <a:ext uri="{FF2B5EF4-FFF2-40B4-BE49-F238E27FC236}">
                <a16:creationId xmlns:a16="http://schemas.microsoft.com/office/drawing/2014/main" id="{08AD7DC2-09DE-AA75-BC71-14547EC61BF0}"/>
              </a:ext>
            </a:extLst>
          </p:cNvPr>
          <p:cNvSpPr/>
          <p:nvPr/>
        </p:nvSpPr>
        <p:spPr>
          <a:xfrm>
            <a:off x="752061" y="2444774"/>
            <a:ext cx="1858593" cy="369332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E5548FF8-A0D9-D53A-2AFF-19BBA501825A}"/>
              </a:ext>
            </a:extLst>
          </p:cNvPr>
          <p:cNvSpPr txBox="1"/>
          <p:nvPr/>
        </p:nvSpPr>
        <p:spPr>
          <a:xfrm>
            <a:off x="223693" y="2444774"/>
            <a:ext cx="50045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600" dirty="0">
                <a:solidFill>
                  <a:srgbClr val="FF000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p62</a:t>
            </a:r>
          </a:p>
        </p:txBody>
      </p:sp>
      <p:sp>
        <p:nvSpPr>
          <p:cNvPr id="11" name="Rectangle 10">
            <a:extLst>
              <a:ext uri="{FF2B5EF4-FFF2-40B4-BE49-F238E27FC236}">
                <a16:creationId xmlns:a16="http://schemas.microsoft.com/office/drawing/2014/main" id="{478DAED6-CB05-E463-CDFE-70C4635EBFDE}"/>
              </a:ext>
            </a:extLst>
          </p:cNvPr>
          <p:cNvSpPr/>
          <p:nvPr/>
        </p:nvSpPr>
        <p:spPr>
          <a:xfrm>
            <a:off x="6729612" y="2895348"/>
            <a:ext cx="1858593" cy="369332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63E24F4C-E0C8-15DB-1011-8FD2A453E2FB}"/>
              </a:ext>
            </a:extLst>
          </p:cNvPr>
          <p:cNvSpPr txBox="1"/>
          <p:nvPr/>
        </p:nvSpPr>
        <p:spPr>
          <a:xfrm>
            <a:off x="5966261" y="2910737"/>
            <a:ext cx="763351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sz="1600" dirty="0">
                <a:solidFill>
                  <a:srgbClr val="FF000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β</a:t>
            </a:r>
            <a:r>
              <a:rPr lang="en-GB" sz="1600" dirty="0">
                <a:solidFill>
                  <a:srgbClr val="FF000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-actin</a:t>
            </a:r>
          </a:p>
        </p:txBody>
      </p:sp>
    </p:spTree>
    <p:extLst>
      <p:ext uri="{BB962C8B-B14F-4D97-AF65-F5344CB8AC3E}">
        <p14:creationId xmlns:p14="http://schemas.microsoft.com/office/powerpoint/2010/main" val="242565922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614586A2-1E3B-9E45-C57C-7D26A58BF5E2}"/>
              </a:ext>
            </a:extLst>
          </p:cNvPr>
          <p:cNvSpPr txBox="1"/>
          <p:nvPr/>
        </p:nvSpPr>
        <p:spPr>
          <a:xfrm>
            <a:off x="0" y="107004"/>
            <a:ext cx="225484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dirty="0">
                <a:latin typeface="Calibri" panose="020F0502020204030204" pitchFamily="34" charset="0"/>
                <a:cs typeface="Calibri" panose="020F0502020204030204" pitchFamily="34" charset="0"/>
              </a:rPr>
              <a:t>HT29_biological replicate n3</a:t>
            </a:r>
          </a:p>
        </p:txBody>
      </p:sp>
      <p:pic>
        <p:nvPicPr>
          <p:cNvPr id="3" name="Picture 2" descr="A close-up of a test&#10;&#10;Description automatically generated">
            <a:extLst>
              <a:ext uri="{FF2B5EF4-FFF2-40B4-BE49-F238E27FC236}">
                <a16:creationId xmlns:a16="http://schemas.microsoft.com/office/drawing/2014/main" id="{04CF67B2-13B5-83E0-4D75-1CF3BCA3DED3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74708" y="1215246"/>
            <a:ext cx="5389513" cy="2894568"/>
          </a:xfrm>
          <a:prstGeom prst="rect">
            <a:avLst/>
          </a:prstGeom>
        </p:spPr>
      </p:pic>
      <p:sp>
        <p:nvSpPr>
          <p:cNvPr id="6" name="Rectangle 5">
            <a:extLst>
              <a:ext uri="{FF2B5EF4-FFF2-40B4-BE49-F238E27FC236}">
                <a16:creationId xmlns:a16="http://schemas.microsoft.com/office/drawing/2014/main" id="{3F0D80C4-6AAD-1B4F-B1DB-CE13307A4AA9}"/>
              </a:ext>
            </a:extLst>
          </p:cNvPr>
          <p:cNvSpPr/>
          <p:nvPr/>
        </p:nvSpPr>
        <p:spPr>
          <a:xfrm>
            <a:off x="853507" y="2408552"/>
            <a:ext cx="1858593" cy="369332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CEE2901F-BC7D-5016-E24C-2F14C1D69B17}"/>
              </a:ext>
            </a:extLst>
          </p:cNvPr>
          <p:cNvSpPr txBox="1"/>
          <p:nvPr/>
        </p:nvSpPr>
        <p:spPr>
          <a:xfrm>
            <a:off x="353049" y="2408552"/>
            <a:ext cx="50045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600" dirty="0">
                <a:solidFill>
                  <a:srgbClr val="FF000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p62</a:t>
            </a:r>
          </a:p>
        </p:txBody>
      </p:sp>
      <p:pic>
        <p:nvPicPr>
          <p:cNvPr id="5" name="Picture 4" descr="A black line on a white background&#10;&#10;Description automatically generated">
            <a:extLst>
              <a:ext uri="{FF2B5EF4-FFF2-40B4-BE49-F238E27FC236}">
                <a16:creationId xmlns:a16="http://schemas.microsoft.com/office/drawing/2014/main" id="{ACC70069-68A4-4A27-11F5-5ABEFECF62F9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095999" y="1215247"/>
            <a:ext cx="5444599" cy="2924154"/>
          </a:xfrm>
          <a:prstGeom prst="rect">
            <a:avLst/>
          </a:prstGeom>
        </p:spPr>
      </p:pic>
      <p:sp>
        <p:nvSpPr>
          <p:cNvPr id="8" name="Rectangle 7">
            <a:extLst>
              <a:ext uri="{FF2B5EF4-FFF2-40B4-BE49-F238E27FC236}">
                <a16:creationId xmlns:a16="http://schemas.microsoft.com/office/drawing/2014/main" id="{1A3EFB10-BF23-B0AC-3751-1BFF46605DB8}"/>
              </a:ext>
            </a:extLst>
          </p:cNvPr>
          <p:cNvSpPr/>
          <p:nvPr/>
        </p:nvSpPr>
        <p:spPr>
          <a:xfrm>
            <a:off x="6859350" y="2662530"/>
            <a:ext cx="1858593" cy="369332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8A726257-8A24-89EF-29EC-C3EBC24C6FF4}"/>
              </a:ext>
            </a:extLst>
          </p:cNvPr>
          <p:cNvSpPr txBox="1"/>
          <p:nvPr/>
        </p:nvSpPr>
        <p:spPr>
          <a:xfrm>
            <a:off x="6095999" y="2693308"/>
            <a:ext cx="763351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sz="1600" dirty="0">
                <a:solidFill>
                  <a:srgbClr val="FF000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β</a:t>
            </a:r>
            <a:r>
              <a:rPr lang="en-GB" sz="1600" dirty="0">
                <a:solidFill>
                  <a:srgbClr val="FF000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-actin</a:t>
            </a:r>
          </a:p>
        </p:txBody>
      </p:sp>
    </p:spTree>
    <p:extLst>
      <p:ext uri="{BB962C8B-B14F-4D97-AF65-F5344CB8AC3E}">
        <p14:creationId xmlns:p14="http://schemas.microsoft.com/office/powerpoint/2010/main" val="212667588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4</TotalTime>
  <Words>24</Words>
  <Application>Microsoft Office PowerPoint</Application>
  <PresentationFormat>Widescreen</PresentationFormat>
  <Paragraphs>9</Paragraphs>
  <Slides>3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8" baseType="lpstr">
      <vt:lpstr>Aptos</vt:lpstr>
      <vt:lpstr>Aptos Display</vt:lpstr>
      <vt:lpstr>Arial</vt:lpstr>
      <vt:lpstr>Calibri</vt:lpstr>
      <vt:lpstr>Office Theme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Hala Estephan</dc:creator>
  <cp:lastModifiedBy>Hala Estephan</cp:lastModifiedBy>
  <cp:revision>5</cp:revision>
  <dcterms:created xsi:type="dcterms:W3CDTF">2024-08-04T19:58:04Z</dcterms:created>
  <dcterms:modified xsi:type="dcterms:W3CDTF">2024-08-12T20:37:35Z</dcterms:modified>
</cp:coreProperties>
</file>